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39E046C0-84DC-4F08-9AFD-0DD7DDF77440}" v="11" dt="2024-12-13T18:25:40.167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1" d="100"/>
          <a:sy n="81" d="100"/>
        </p:scale>
        <p:origin x="96" y="47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hi, Yingli" userId="33121c31-2908-4d69-9ce0-32c367360fd8" providerId="ADAL" clId="{39E046C0-84DC-4F08-9AFD-0DD7DDF77440}"/>
    <pc:docChg chg="undo custSel addSld modSld">
      <pc:chgData name="Shi, Yingli" userId="33121c31-2908-4d69-9ce0-32c367360fd8" providerId="ADAL" clId="{39E046C0-84DC-4F08-9AFD-0DD7DDF77440}" dt="2024-12-13T18:28:10.187" v="92" actId="1076"/>
      <pc:docMkLst>
        <pc:docMk/>
      </pc:docMkLst>
      <pc:sldChg chg="addSp delSp modSp new mod">
        <pc:chgData name="Shi, Yingli" userId="33121c31-2908-4d69-9ce0-32c367360fd8" providerId="ADAL" clId="{39E046C0-84DC-4F08-9AFD-0DD7DDF77440}" dt="2024-12-13T18:28:10.187" v="92" actId="1076"/>
        <pc:sldMkLst>
          <pc:docMk/>
          <pc:sldMk cId="1954764243" sldId="256"/>
        </pc:sldMkLst>
        <pc:spChg chg="add mod">
          <ac:chgData name="Shi, Yingli" userId="33121c31-2908-4d69-9ce0-32c367360fd8" providerId="ADAL" clId="{39E046C0-84DC-4F08-9AFD-0DD7DDF77440}" dt="2024-12-13T18:24:59.351" v="65" actId="1037"/>
          <ac:spMkLst>
            <pc:docMk/>
            <pc:sldMk cId="1954764243" sldId="256"/>
            <ac:spMk id="2" creationId="{8B4BACA4-7E66-34E3-A406-97314EBEACA7}"/>
          </ac:spMkLst>
        </pc:spChg>
        <pc:spChg chg="del">
          <ac:chgData name="Shi, Yingli" userId="33121c31-2908-4d69-9ce0-32c367360fd8" providerId="ADAL" clId="{39E046C0-84DC-4F08-9AFD-0DD7DDF77440}" dt="2024-12-11T19:29:02.547" v="1" actId="478"/>
          <ac:spMkLst>
            <pc:docMk/>
            <pc:sldMk cId="1954764243" sldId="256"/>
            <ac:spMk id="2" creationId="{EC99BD51-9C58-4E40-6BC5-2036B417FC9F}"/>
          </ac:spMkLst>
        </pc:spChg>
        <pc:spChg chg="del">
          <ac:chgData name="Shi, Yingli" userId="33121c31-2908-4d69-9ce0-32c367360fd8" providerId="ADAL" clId="{39E046C0-84DC-4F08-9AFD-0DD7DDF77440}" dt="2024-12-11T19:29:04.353" v="2" actId="478"/>
          <ac:spMkLst>
            <pc:docMk/>
            <pc:sldMk cId="1954764243" sldId="256"/>
            <ac:spMk id="3" creationId="{065C8D37-1C9F-494D-4725-247032DCAEA2}"/>
          </ac:spMkLst>
        </pc:spChg>
        <pc:spChg chg="add mod">
          <ac:chgData name="Shi, Yingli" userId="33121c31-2908-4d69-9ce0-32c367360fd8" providerId="ADAL" clId="{39E046C0-84DC-4F08-9AFD-0DD7DDF77440}" dt="2024-12-13T18:25:09.017" v="69" actId="1076"/>
          <ac:spMkLst>
            <pc:docMk/>
            <pc:sldMk cId="1954764243" sldId="256"/>
            <ac:spMk id="3" creationId="{60DA1C92-2412-566F-ED6D-F73E8B744B49}"/>
          </ac:spMkLst>
        </pc:spChg>
        <pc:spChg chg="add mod">
          <ac:chgData name="Shi, Yingli" userId="33121c31-2908-4d69-9ce0-32c367360fd8" providerId="ADAL" clId="{39E046C0-84DC-4F08-9AFD-0DD7DDF77440}" dt="2024-12-13T18:25:19.295" v="73" actId="1037"/>
          <ac:spMkLst>
            <pc:docMk/>
            <pc:sldMk cId="1954764243" sldId="256"/>
            <ac:spMk id="4" creationId="{ACF2B948-26B6-7371-E8C4-E21788D71475}"/>
          </ac:spMkLst>
        </pc:spChg>
        <pc:spChg chg="add mod">
          <ac:chgData name="Shi, Yingli" userId="33121c31-2908-4d69-9ce0-32c367360fd8" providerId="ADAL" clId="{39E046C0-84DC-4F08-9AFD-0DD7DDF77440}" dt="2024-12-13T18:25:29.412" v="76" actId="20577"/>
          <ac:spMkLst>
            <pc:docMk/>
            <pc:sldMk cId="1954764243" sldId="256"/>
            <ac:spMk id="6" creationId="{EFBE5B3E-44AB-28A1-8751-2226F1BBA558}"/>
          </ac:spMkLst>
        </pc:spChg>
        <pc:spChg chg="add mod">
          <ac:chgData name="Shi, Yingli" userId="33121c31-2908-4d69-9ce0-32c367360fd8" providerId="ADAL" clId="{39E046C0-84DC-4F08-9AFD-0DD7DDF77440}" dt="2024-12-13T18:25:38.540" v="79" actId="20577"/>
          <ac:spMkLst>
            <pc:docMk/>
            <pc:sldMk cId="1954764243" sldId="256"/>
            <ac:spMk id="8" creationId="{00908D60-AB16-E473-C0AB-87B54F6AA6F4}"/>
          </ac:spMkLst>
        </pc:spChg>
        <pc:spChg chg="add mod">
          <ac:chgData name="Shi, Yingli" userId="33121c31-2908-4d69-9ce0-32c367360fd8" providerId="ADAL" clId="{39E046C0-84DC-4F08-9AFD-0DD7DDF77440}" dt="2024-12-11T19:30:35.934" v="40" actId="1076"/>
          <ac:spMkLst>
            <pc:docMk/>
            <pc:sldMk cId="1954764243" sldId="256"/>
            <ac:spMk id="10" creationId="{FBC5F19A-FB01-5A7E-D806-D69BE5C7920F}"/>
          </ac:spMkLst>
        </pc:spChg>
        <pc:spChg chg="add mod">
          <ac:chgData name="Shi, Yingli" userId="33121c31-2908-4d69-9ce0-32c367360fd8" providerId="ADAL" clId="{39E046C0-84DC-4F08-9AFD-0DD7DDF77440}" dt="2024-12-11T19:30:40.668" v="48" actId="20577"/>
          <ac:spMkLst>
            <pc:docMk/>
            <pc:sldMk cId="1954764243" sldId="256"/>
            <ac:spMk id="11" creationId="{6AA19F25-1A24-E321-2A83-E7C0F22A22FF}"/>
          </ac:spMkLst>
        </pc:spChg>
        <pc:spChg chg="add mod">
          <ac:chgData name="Shi, Yingli" userId="33121c31-2908-4d69-9ce0-32c367360fd8" providerId="ADAL" clId="{39E046C0-84DC-4F08-9AFD-0DD7DDF77440}" dt="2024-12-11T19:30:49.793" v="61" actId="20577"/>
          <ac:spMkLst>
            <pc:docMk/>
            <pc:sldMk cId="1954764243" sldId="256"/>
            <ac:spMk id="12" creationId="{6FF5F02A-BA62-1C56-1EDD-D65CBD12A41C}"/>
          </ac:spMkLst>
        </pc:spChg>
        <pc:spChg chg="add mod">
          <ac:chgData name="Shi, Yingli" userId="33121c31-2908-4d69-9ce0-32c367360fd8" providerId="ADAL" clId="{39E046C0-84DC-4F08-9AFD-0DD7DDF77440}" dt="2024-12-13T18:25:44.949" v="82" actId="20577"/>
          <ac:spMkLst>
            <pc:docMk/>
            <pc:sldMk cId="1954764243" sldId="256"/>
            <ac:spMk id="13" creationId="{818E2F64-6F74-B1AA-2679-86A21167862D}"/>
          </ac:spMkLst>
        </pc:spChg>
        <pc:spChg chg="add mod">
          <ac:chgData name="Shi, Yingli" userId="33121c31-2908-4d69-9ce0-32c367360fd8" providerId="ADAL" clId="{39E046C0-84DC-4F08-9AFD-0DD7DDF77440}" dt="2024-12-13T18:28:10.187" v="92" actId="1076"/>
          <ac:spMkLst>
            <pc:docMk/>
            <pc:sldMk cId="1954764243" sldId="256"/>
            <ac:spMk id="15" creationId="{E1B74794-8EF1-54B0-8FCC-12E56EB69677}"/>
          </ac:spMkLst>
        </pc:spChg>
        <pc:picChg chg="add mod">
          <ac:chgData name="Shi, Yingli" userId="33121c31-2908-4d69-9ce0-32c367360fd8" providerId="ADAL" clId="{39E046C0-84DC-4F08-9AFD-0DD7DDF77440}" dt="2024-12-13T18:27:31.068" v="87" actId="1076"/>
          <ac:picMkLst>
            <pc:docMk/>
            <pc:sldMk cId="1954764243" sldId="256"/>
            <ac:picMk id="5" creationId="{19D26F0D-6504-E284-15C5-93F72EEF4809}"/>
          </ac:picMkLst>
        </pc:picChg>
        <pc:picChg chg="add mod">
          <ac:chgData name="Shi, Yingli" userId="33121c31-2908-4d69-9ce0-32c367360fd8" providerId="ADAL" clId="{39E046C0-84DC-4F08-9AFD-0DD7DDF77440}" dt="2024-12-11T19:30:15.917" v="31" actId="1076"/>
          <ac:picMkLst>
            <pc:docMk/>
            <pc:sldMk cId="1954764243" sldId="256"/>
            <ac:picMk id="7" creationId="{CEA60278-E8AD-4A9C-847C-2DFFD52421C2}"/>
          </ac:picMkLst>
        </pc:picChg>
        <pc:picChg chg="add mod">
          <ac:chgData name="Shi, Yingli" userId="33121c31-2908-4d69-9ce0-32c367360fd8" providerId="ADAL" clId="{39E046C0-84DC-4F08-9AFD-0DD7DDF77440}" dt="2024-12-11T19:30:11.449" v="29" actId="14100"/>
          <ac:picMkLst>
            <pc:docMk/>
            <pc:sldMk cId="1954764243" sldId="256"/>
            <ac:picMk id="9" creationId="{368D8FEA-49E5-AE18-ED9E-688825136454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232AF3-2D8F-24A6-9AE8-ABC02E740B5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6B6E091-C28F-E650-D364-0BD0D7F3B07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DC10A2E-9A46-AC21-D19D-4DD72156F3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B385D6-3542-461F-9E42-08AD3CD4ABC2}" type="datetimeFigureOut">
              <a:rPr lang="en-US" smtClean="0"/>
              <a:t>12/13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3353851-5693-503B-E6BB-7381E4CECC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8ED5D17-DB5E-82C9-FC85-9FD75F01BF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E58655-0E4F-4037-AC90-A5BB3A0FBE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46000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28415FC-0BFC-C226-FF57-368E16910AB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1237F10-E215-07EF-3139-C4898230ACB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D4F2449-3102-505D-7AE2-304C265763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B385D6-3542-461F-9E42-08AD3CD4ABC2}" type="datetimeFigureOut">
              <a:rPr lang="en-US" smtClean="0"/>
              <a:t>12/13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A3B8545-066B-86D7-01D5-CDB90E7FC4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B5E78C2-A8E0-159B-9374-FCF953DC20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E58655-0E4F-4037-AC90-A5BB3A0FBE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61150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C7AC81D-6244-6ACE-F4A3-0CFE49BF249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E5B6C0E-CB1D-7FCA-80F5-E2987A560B0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F5F05B6-9BB8-1308-DE84-52B6F904C4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B385D6-3542-461F-9E42-08AD3CD4ABC2}" type="datetimeFigureOut">
              <a:rPr lang="en-US" smtClean="0"/>
              <a:t>12/13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E1BBA11-CE7A-3EC3-6A19-D3233B94CC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1646FF2-3351-4D59-0C75-2613381B51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E58655-0E4F-4037-AC90-A5BB3A0FBE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70749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FEC729F-05DE-8465-7AF4-D83C0124074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CA603D6-6621-1214-4641-FC844257C3F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1585005-455A-288D-3E48-03DD544CA0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B385D6-3542-461F-9E42-08AD3CD4ABC2}" type="datetimeFigureOut">
              <a:rPr lang="en-US" smtClean="0"/>
              <a:t>12/13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62647C2-EACE-4AF3-8FA0-95A8E1C830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DC650C6-7402-9B58-3485-E552C1FB45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E58655-0E4F-4037-AC90-A5BB3A0FBE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60396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31C1F3C-1243-2061-79ED-22FFC992F18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4F9E0E8-C95F-0226-520B-12C09CEBB7F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82E9785-E404-8F95-BE53-AB9199FAA7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B385D6-3542-461F-9E42-08AD3CD4ABC2}" type="datetimeFigureOut">
              <a:rPr lang="en-US" smtClean="0"/>
              <a:t>12/13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8B56B2A-C6E6-2347-9A96-27A96A8AD8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3BA6EAA-7F09-74A5-AFB4-76665C77D3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E58655-0E4F-4037-AC90-A5BB3A0FBE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60858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16723A0-4581-A275-F9AB-BC3B5EFAD66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97DDF1A-E785-1906-6B1A-991295CD058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34ABD86-687C-D172-F5FA-26BCE11E0F4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09DC428-5F54-E32B-9A59-CA39B4BBFC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B385D6-3542-461F-9E42-08AD3CD4ABC2}" type="datetimeFigureOut">
              <a:rPr lang="en-US" smtClean="0"/>
              <a:t>12/13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C8C850E-9C5B-7334-67E1-662CBA8E36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8F2F3F0-53E5-E9AC-0B5B-2AD1379463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E58655-0E4F-4037-AC90-A5BB3A0FBE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6967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4618F13-D247-A96B-B93B-054B6CDF044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7EC05C8-DF19-13DC-2094-6D4D42E7583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DFFDC3A-227D-B385-70E9-1797D32945A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A999702-87F1-E636-64E1-D1784C72296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2B86804-F00B-2523-0B61-7808896FF3D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A2F4EF3-271D-68BE-540D-8088135649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B385D6-3542-461F-9E42-08AD3CD4ABC2}" type="datetimeFigureOut">
              <a:rPr lang="en-US" smtClean="0"/>
              <a:t>12/13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F479F29-D50C-9DE2-D00C-C1F2637543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3245789-5160-27C5-B8AD-013C88E74B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E58655-0E4F-4037-AC90-A5BB3A0FBE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00152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43EBA39-C530-8118-E966-F04F35AB90D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08C4BCB-603D-20DF-F3A3-991BB3F359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B385D6-3542-461F-9E42-08AD3CD4ABC2}" type="datetimeFigureOut">
              <a:rPr lang="en-US" smtClean="0"/>
              <a:t>12/13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5DB20AB-B1FF-2567-F187-8945C0E171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B266949-3BDB-802E-7E2A-A13935344D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E58655-0E4F-4037-AC90-A5BB3A0FBE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94268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2D71F37-A265-5542-923E-F8744E3FC4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B385D6-3542-461F-9E42-08AD3CD4ABC2}" type="datetimeFigureOut">
              <a:rPr lang="en-US" smtClean="0"/>
              <a:t>12/13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A86E297-88FF-B6E7-0B6E-AAC5BAA6E0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C1073D4-D240-6106-CB8F-C3BF438C90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E58655-0E4F-4037-AC90-A5BB3A0FBE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62314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DED4AF9-58AA-1970-7E76-3BAD7195148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BAA66DE-375C-81A9-AEEA-4F3CF95B9BA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6AD8C3E-2986-A9D5-D4BB-B0D777FB783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A11FDD3-A0F8-D4F4-156E-E84F8FAE1D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B385D6-3542-461F-9E42-08AD3CD4ABC2}" type="datetimeFigureOut">
              <a:rPr lang="en-US" smtClean="0"/>
              <a:t>12/13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FD1F419-814D-179E-541B-05651B78E5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D0E7181-3019-24EF-8920-9D1D1A5405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E58655-0E4F-4037-AC90-A5BB3A0FBE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7177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035500F-614B-5C37-DE19-FFAFDF7D874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094CD16-B780-B28D-4831-E9F09894956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734B08E-5D63-8A91-1E1A-6E1A629FF25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60F6A9F-9A8C-E88D-1416-74B38C62F9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B385D6-3542-461F-9E42-08AD3CD4ABC2}" type="datetimeFigureOut">
              <a:rPr lang="en-US" smtClean="0"/>
              <a:t>12/13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D96127F-F919-543F-AC7D-8A8A18F865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56D70AB-22B9-8B93-A88E-3C9802002B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E58655-0E4F-4037-AC90-A5BB3A0FBE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21782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AA32389-D44E-7AA0-3E34-3103569E0D3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B03A584-5E3F-AD37-7319-610AFD93A52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FEEE4B6-66C7-6676-F4BA-A4D4935B95A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FB385D6-3542-461F-9E42-08AD3CD4ABC2}" type="datetimeFigureOut">
              <a:rPr lang="en-US" smtClean="0"/>
              <a:t>12/13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3C0778A-A21C-62AB-E39B-79080DBE226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6FA6C1A-6BE1-1528-5820-CF7FC46368D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4E58655-0E4F-4037-AC90-A5BB3A0FBE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91378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19D26F0D-6504-E284-15C5-93F72EEF480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0500" y="1767701"/>
            <a:ext cx="3657600" cy="2927458"/>
          </a:xfrm>
          <a:prstGeom prst="rect">
            <a:avLst/>
          </a:prstGeom>
        </p:spPr>
      </p:pic>
      <p:pic>
        <p:nvPicPr>
          <p:cNvPr id="7" name="Picture 6" descr="A test strip with a sample of dna&#10;&#10;Description automatically generated with medium confidence">
            <a:extLst>
              <a:ext uri="{FF2B5EF4-FFF2-40B4-BE49-F238E27FC236}">
                <a16:creationId xmlns:a16="http://schemas.microsoft.com/office/drawing/2014/main" id="{CEA60278-E8AD-4A9C-847C-2DFFD52421C2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33850" y="1767024"/>
            <a:ext cx="3657600" cy="2928135"/>
          </a:xfrm>
          <a:prstGeom prst="rect">
            <a:avLst/>
          </a:prstGeom>
        </p:spPr>
      </p:pic>
      <p:pic>
        <p:nvPicPr>
          <p:cNvPr id="9" name="Picture 8" descr="A white paper with black text&#10;&#10;Description automatically generated">
            <a:extLst>
              <a:ext uri="{FF2B5EF4-FFF2-40B4-BE49-F238E27FC236}">
                <a16:creationId xmlns:a16="http://schemas.microsoft.com/office/drawing/2014/main" id="{368D8FEA-49E5-AE18-ED9E-688825136454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77200" y="1781162"/>
            <a:ext cx="3657600" cy="2927356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FBC5F19A-FB01-5A7E-D806-D69BE5C7920F}"/>
              </a:ext>
            </a:extLst>
          </p:cNvPr>
          <p:cNvSpPr txBox="1"/>
          <p:nvPr/>
        </p:nvSpPr>
        <p:spPr>
          <a:xfrm>
            <a:off x="1517321" y="1411830"/>
            <a:ext cx="19831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TMN1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6AA19F25-1A24-E321-2A83-E7C0F22A22FF}"/>
              </a:ext>
            </a:extLst>
          </p:cNvPr>
          <p:cNvSpPr txBox="1"/>
          <p:nvPr/>
        </p:nvSpPr>
        <p:spPr>
          <a:xfrm>
            <a:off x="5615050" y="1393970"/>
            <a:ext cx="19831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E2F1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6FF5F02A-BA62-1C56-1EDD-D65CBD12A41C}"/>
              </a:ext>
            </a:extLst>
          </p:cNvPr>
          <p:cNvSpPr txBox="1"/>
          <p:nvPr/>
        </p:nvSpPr>
        <p:spPr>
          <a:xfrm>
            <a:off x="9558400" y="1411830"/>
            <a:ext cx="19831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eta-actin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8B4BACA4-7E66-34E3-A406-97314EBEACA7}"/>
              </a:ext>
            </a:extLst>
          </p:cNvPr>
          <p:cNvSpPr/>
          <p:nvPr/>
        </p:nvSpPr>
        <p:spPr>
          <a:xfrm>
            <a:off x="795647" y="2980706"/>
            <a:ext cx="2553195" cy="3693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60DA1C92-2412-566F-ED6D-F73E8B744B49}"/>
              </a:ext>
            </a:extLst>
          </p:cNvPr>
          <p:cNvSpPr/>
          <p:nvPr/>
        </p:nvSpPr>
        <p:spPr>
          <a:xfrm>
            <a:off x="4695578" y="2875508"/>
            <a:ext cx="2534144" cy="3693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ACF2B948-26B6-7371-E8C4-E21788D71475}"/>
              </a:ext>
            </a:extLst>
          </p:cNvPr>
          <p:cNvSpPr/>
          <p:nvPr/>
        </p:nvSpPr>
        <p:spPr>
          <a:xfrm>
            <a:off x="8906494" y="3447411"/>
            <a:ext cx="2264228" cy="3693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EFBE5B3E-44AB-28A1-8751-2226F1BBA558}"/>
              </a:ext>
            </a:extLst>
          </p:cNvPr>
          <p:cNvSpPr txBox="1"/>
          <p:nvPr/>
        </p:nvSpPr>
        <p:spPr>
          <a:xfrm>
            <a:off x="190500" y="1450919"/>
            <a:ext cx="19831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00908D60-AB16-E473-C0AB-87B54F6AA6F4}"/>
              </a:ext>
            </a:extLst>
          </p:cNvPr>
          <p:cNvSpPr txBox="1"/>
          <p:nvPr/>
        </p:nvSpPr>
        <p:spPr>
          <a:xfrm>
            <a:off x="4112821" y="1450919"/>
            <a:ext cx="19831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818E2F64-6F74-B1AA-2679-86A21167862D}"/>
              </a:ext>
            </a:extLst>
          </p:cNvPr>
          <p:cNvSpPr txBox="1"/>
          <p:nvPr/>
        </p:nvSpPr>
        <p:spPr>
          <a:xfrm>
            <a:off x="8055429" y="1450919"/>
            <a:ext cx="19831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E1B74794-8EF1-54B0-8FCC-12E56EB69677}"/>
              </a:ext>
            </a:extLst>
          </p:cNvPr>
          <p:cNvSpPr txBox="1"/>
          <p:nvPr/>
        </p:nvSpPr>
        <p:spPr>
          <a:xfrm>
            <a:off x="190500" y="5077850"/>
            <a:ext cx="11544300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spcAft>
                <a:spcPts val="800"/>
              </a:spcAft>
              <a:tabLst>
                <a:tab pos="228600" algn="l"/>
              </a:tabLst>
            </a:pPr>
            <a:r>
              <a:rPr lang="en-US" sz="16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Supplementary Figure 1. Original western blot images showing protein expression of STMN1 (A) and E2F1 (B) in prostate cancer (PCa) cell lines, with β-actin (C) used as a loading control. The cell lines, arranged from left to right, are VCaP, LNCaP, C42B, 22RV1, PC3, DU145, and NCI-H660.</a:t>
            </a:r>
            <a:endParaRPr lang="en-US" sz="16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547642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73</Words>
  <Application>Microsoft Office PowerPoint</Application>
  <PresentationFormat>Widescreen</PresentationFormat>
  <Paragraphs>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ptos</vt:lpstr>
      <vt:lpstr>Aptos Display</vt:lpstr>
      <vt:lpstr>Arial</vt:lpstr>
      <vt:lpstr>Calibri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Shi, Yingli</dc:creator>
  <cp:lastModifiedBy>Shi, Yingli</cp:lastModifiedBy>
  <cp:revision>1</cp:revision>
  <dcterms:created xsi:type="dcterms:W3CDTF">2024-12-11T19:28:35Z</dcterms:created>
  <dcterms:modified xsi:type="dcterms:W3CDTF">2024-12-13T18:28:11Z</dcterms:modified>
</cp:coreProperties>
</file>